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4" r:id="rId2"/>
    <p:sldId id="266" r:id="rId3"/>
    <p:sldId id="267" r:id="rId4"/>
  </p:sldIdLst>
  <p:sldSz cx="6858000" cy="9144000" type="screen4x3"/>
  <p:notesSz cx="7099300" cy="1023461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8" d="100"/>
          <a:sy n="88" d="100"/>
        </p:scale>
        <p:origin x="2940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otake\Desktop\180604%20&#20877;&#32232;&#38598;%20STZ&#12521;&#12483;&#12488;&#12503;&#12525;&#12486;&#12458;&#12540;&#12512;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otake\Desktop\180604%20&#20877;&#32232;&#38598;%20STZ&#12521;&#12483;&#12488;&#12503;&#12525;&#12486;&#12458;&#12540;&#12512;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otake\Desktop\180604%20&#20877;&#32232;&#38598;%20STZ&#12521;&#12483;&#12488;&#12503;&#12525;&#12486;&#12458;&#12540;&#12512;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cat>
            <c:strRef>
              <c:f>'cornea-biological process'!$B$2:$B$8</c:f>
              <c:strCache>
                <c:ptCount val="7"/>
                <c:pt idx="0">
                  <c:v>Cytoskeleton organization</c:v>
                </c:pt>
                <c:pt idx="1">
                  <c:v>Cell-cell adhesion</c:v>
                </c:pt>
                <c:pt idx="2">
                  <c:v>Microtubule-based process</c:v>
                </c:pt>
                <c:pt idx="3">
                  <c:v>Acute-phase response</c:v>
                </c:pt>
                <c:pt idx="4">
                  <c:v>Translational elongation</c:v>
                </c:pt>
                <c:pt idx="5">
                  <c:v>Actin filament capping</c:v>
                </c:pt>
                <c:pt idx="6">
                  <c:v>Protein transport</c:v>
                </c:pt>
              </c:strCache>
            </c:strRef>
          </c:cat>
          <c:val>
            <c:numRef>
              <c:f>'cornea-biological process'!$D$2:$D$8</c:f>
              <c:numCache>
                <c:formatCode>General</c:formatCode>
                <c:ptCount val="7"/>
                <c:pt idx="0">
                  <c:v>6.9148936170212698</c:v>
                </c:pt>
                <c:pt idx="1">
                  <c:v>6.9148936170212698</c:v>
                </c:pt>
                <c:pt idx="2">
                  <c:v>3.72340425531914</c:v>
                </c:pt>
                <c:pt idx="3">
                  <c:v>2.6595744680851001</c:v>
                </c:pt>
                <c:pt idx="4">
                  <c:v>2.1276595744680802</c:v>
                </c:pt>
                <c:pt idx="5">
                  <c:v>1.59574468085106</c:v>
                </c:pt>
                <c:pt idx="6">
                  <c:v>4.787234042553190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931E-471F-BBD5-DC11D654F7A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14197968"/>
        <c:axId val="314196792"/>
      </c:barChart>
      <c:catAx>
        <c:axId val="314197968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spPr>
          <a:ln w="19050">
            <a:solidFill>
              <a:schemeClr val="tx1"/>
            </a:solidFill>
          </a:ln>
        </c:spPr>
        <c:txPr>
          <a:bodyPr rot="-5400000" vert="horz"/>
          <a:lstStyle/>
          <a:p>
            <a:pPr>
              <a:defRPr/>
            </a:pPr>
            <a:endParaRPr lang="ja-JP"/>
          </a:p>
        </c:txPr>
        <c:crossAx val="314196792"/>
        <c:crosses val="autoZero"/>
        <c:auto val="1"/>
        <c:lblAlgn val="ctr"/>
        <c:lblOffset val="100"/>
        <c:noMultiLvlLbl val="0"/>
      </c:catAx>
      <c:valAx>
        <c:axId val="314196792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Relative abundance (%)</a:t>
                </a:r>
                <a:endParaRPr lang="ja-JP"/>
              </a:p>
            </c:rich>
          </c:tx>
          <c:layout/>
          <c:overlay val="0"/>
        </c:title>
        <c:numFmt formatCode="General" sourceLinked="1"/>
        <c:majorTickMark val="in"/>
        <c:minorTickMark val="none"/>
        <c:tickLblPos val="nextTo"/>
        <c:spPr>
          <a:ln w="19050">
            <a:solidFill>
              <a:schemeClr val="tx1"/>
            </a:solidFill>
          </a:ln>
        </c:spPr>
        <c:crossAx val="314197968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1050" b="1"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14200320"/>
        <c:axId val="314202672"/>
      </c:barChart>
      <c:catAx>
        <c:axId val="314200320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spPr>
          <a:ln w="19050">
            <a:solidFill>
              <a:schemeClr val="tx1"/>
            </a:solidFill>
          </a:ln>
        </c:spPr>
        <c:txPr>
          <a:bodyPr rot="-5400000" vert="horz"/>
          <a:lstStyle/>
          <a:p>
            <a:pPr>
              <a:defRPr/>
            </a:pPr>
            <a:endParaRPr lang="ja-JP"/>
          </a:p>
        </c:txPr>
        <c:crossAx val="314202672"/>
        <c:crosses val="autoZero"/>
        <c:auto val="1"/>
        <c:lblAlgn val="ctr"/>
        <c:lblOffset val="100"/>
        <c:noMultiLvlLbl val="0"/>
      </c:catAx>
      <c:valAx>
        <c:axId val="314202672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Relative abundance (%)</a:t>
                </a:r>
                <a:endParaRPr lang="ja-JP"/>
              </a:p>
            </c:rich>
          </c:tx>
          <c:layout/>
          <c:overlay val="0"/>
        </c:title>
        <c:numFmt formatCode="General" sourceLinked="1"/>
        <c:majorTickMark val="in"/>
        <c:minorTickMark val="none"/>
        <c:tickLblPos val="nextTo"/>
        <c:spPr>
          <a:ln w="19050">
            <a:solidFill>
              <a:schemeClr val="tx1"/>
            </a:solidFill>
          </a:ln>
        </c:spPr>
        <c:crossAx val="314200320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1050" b="1"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cat>
            <c:strRef>
              <c:f>'cornea-pathway'!$B$2:$B$13</c:f>
              <c:strCache>
                <c:ptCount val="12"/>
                <c:pt idx="0">
                  <c:v>Gap junction</c:v>
                </c:pt>
                <c:pt idx="1">
                  <c:v>Phagosome</c:v>
                </c:pt>
                <c:pt idx="2">
                  <c:v>Glycolysis / Gluconeogenesis</c:v>
                </c:pt>
                <c:pt idx="3">
                  <c:v>Cysteine and methionine metabolism</c:v>
                </c:pt>
                <c:pt idx="4">
                  <c:v>Legionellosis</c:v>
                </c:pt>
                <c:pt idx="5">
                  <c:v>Ribosome</c:v>
                </c:pt>
                <c:pt idx="6">
                  <c:v>Complement and coagulation cascades</c:v>
                </c:pt>
                <c:pt idx="7">
                  <c:v>Pyruvate metabolism</c:v>
                </c:pt>
                <c:pt idx="8">
                  <c:v>Biosynthesis of amino acids</c:v>
                </c:pt>
                <c:pt idx="9">
                  <c:v>Systemic lupus erythematosus</c:v>
                </c:pt>
                <c:pt idx="10">
                  <c:v>Glucagon signaling pathway</c:v>
                </c:pt>
                <c:pt idx="11">
                  <c:v>Propanoate metabolism</c:v>
                </c:pt>
              </c:strCache>
            </c:strRef>
          </c:cat>
          <c:val>
            <c:numRef>
              <c:f>'cornea-pathway'!$D$2:$D$13</c:f>
              <c:numCache>
                <c:formatCode>General</c:formatCode>
                <c:ptCount val="12"/>
                <c:pt idx="0">
                  <c:v>4.2553191489361701</c:v>
                </c:pt>
                <c:pt idx="1">
                  <c:v>5.8510638297872299</c:v>
                </c:pt>
                <c:pt idx="2">
                  <c:v>3.72340425531914</c:v>
                </c:pt>
                <c:pt idx="3">
                  <c:v>2.6595744680851001</c:v>
                </c:pt>
                <c:pt idx="4">
                  <c:v>2.6595744680851001</c:v>
                </c:pt>
                <c:pt idx="5">
                  <c:v>4.2553191489361701</c:v>
                </c:pt>
                <c:pt idx="6">
                  <c:v>2.6595744680851001</c:v>
                </c:pt>
                <c:pt idx="7">
                  <c:v>2.1276595744680802</c:v>
                </c:pt>
                <c:pt idx="8">
                  <c:v>2.6595744680851001</c:v>
                </c:pt>
                <c:pt idx="9">
                  <c:v>3.1914893617021201</c:v>
                </c:pt>
                <c:pt idx="10">
                  <c:v>2.6595744680851001</c:v>
                </c:pt>
                <c:pt idx="11">
                  <c:v>1.5957446808510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A95D-4227-9451-983542DBA38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14200712"/>
        <c:axId val="314196008"/>
      </c:barChart>
      <c:catAx>
        <c:axId val="314200712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spPr>
          <a:ln w="19050">
            <a:solidFill>
              <a:schemeClr val="tx1"/>
            </a:solidFill>
          </a:ln>
        </c:spPr>
        <c:txPr>
          <a:bodyPr rot="-5400000" vert="horz"/>
          <a:lstStyle/>
          <a:p>
            <a:pPr>
              <a:defRPr/>
            </a:pPr>
            <a:endParaRPr lang="ja-JP"/>
          </a:p>
        </c:txPr>
        <c:crossAx val="314196008"/>
        <c:crosses val="autoZero"/>
        <c:auto val="1"/>
        <c:lblAlgn val="ctr"/>
        <c:lblOffset val="100"/>
        <c:noMultiLvlLbl val="0"/>
      </c:catAx>
      <c:valAx>
        <c:axId val="314196008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Relative abundance (%)</a:t>
                </a:r>
                <a:endParaRPr lang="ja-JP"/>
              </a:p>
            </c:rich>
          </c:tx>
          <c:layout/>
          <c:overlay val="0"/>
        </c:title>
        <c:numFmt formatCode="General" sourceLinked="1"/>
        <c:majorTickMark val="in"/>
        <c:minorTickMark val="none"/>
        <c:tickLblPos val="nextTo"/>
        <c:spPr>
          <a:ln w="19050">
            <a:solidFill>
              <a:schemeClr val="tx1"/>
            </a:solidFill>
          </a:ln>
        </c:spPr>
        <c:crossAx val="314200712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1050" b="1"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79FC64-C493-43E1-B04A-8BA391D43B65}" type="datetimeFigureOut">
              <a:rPr kumimoji="1" lang="ja-JP" altLang="en-US" smtClean="0"/>
              <a:t>2018/6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5CF79-C209-46AB-898C-4C0CD7FECDF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594643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79FC64-C493-43E1-B04A-8BA391D43B65}" type="datetimeFigureOut">
              <a:rPr kumimoji="1" lang="ja-JP" altLang="en-US" smtClean="0"/>
              <a:t>2018/6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5CF79-C209-46AB-898C-4C0CD7FECDF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701562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79FC64-C493-43E1-B04A-8BA391D43B65}" type="datetimeFigureOut">
              <a:rPr kumimoji="1" lang="ja-JP" altLang="en-US" smtClean="0"/>
              <a:t>2018/6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5CF79-C209-46AB-898C-4C0CD7FECDF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724798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79FC64-C493-43E1-B04A-8BA391D43B65}" type="datetimeFigureOut">
              <a:rPr kumimoji="1" lang="ja-JP" altLang="en-US" smtClean="0"/>
              <a:t>2018/6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5CF79-C209-46AB-898C-4C0CD7FECDF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789844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79FC64-C493-43E1-B04A-8BA391D43B65}" type="datetimeFigureOut">
              <a:rPr kumimoji="1" lang="ja-JP" altLang="en-US" smtClean="0"/>
              <a:t>2018/6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5CF79-C209-46AB-898C-4C0CD7FECDF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326950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79FC64-C493-43E1-B04A-8BA391D43B65}" type="datetimeFigureOut">
              <a:rPr kumimoji="1" lang="ja-JP" altLang="en-US" smtClean="0"/>
              <a:t>2018/6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5CF79-C209-46AB-898C-4C0CD7FECDF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980811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79FC64-C493-43E1-B04A-8BA391D43B65}" type="datetimeFigureOut">
              <a:rPr kumimoji="1" lang="ja-JP" altLang="en-US" smtClean="0"/>
              <a:t>2018/6/22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5CF79-C209-46AB-898C-4C0CD7FECDF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645547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79FC64-C493-43E1-B04A-8BA391D43B65}" type="datetimeFigureOut">
              <a:rPr kumimoji="1" lang="ja-JP" altLang="en-US" smtClean="0"/>
              <a:t>2018/6/22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5CF79-C209-46AB-898C-4C0CD7FECDF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838288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79FC64-C493-43E1-B04A-8BA391D43B65}" type="datetimeFigureOut">
              <a:rPr kumimoji="1" lang="ja-JP" altLang="en-US" smtClean="0"/>
              <a:t>2018/6/22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5CF79-C209-46AB-898C-4C0CD7FECDF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292416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79FC64-C493-43E1-B04A-8BA391D43B65}" type="datetimeFigureOut">
              <a:rPr kumimoji="1" lang="ja-JP" altLang="en-US" smtClean="0"/>
              <a:t>2018/6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5CF79-C209-46AB-898C-4C0CD7FECDF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970662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79FC64-C493-43E1-B04A-8BA391D43B65}" type="datetimeFigureOut">
              <a:rPr kumimoji="1" lang="ja-JP" altLang="en-US" smtClean="0"/>
              <a:t>2018/6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5CF79-C209-46AB-898C-4C0CD7FECDF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473281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79FC64-C493-43E1-B04A-8BA391D43B65}" type="datetimeFigureOut">
              <a:rPr kumimoji="1" lang="ja-JP" altLang="en-US" smtClean="0"/>
              <a:t>2018/6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65CF79-C209-46AB-898C-4C0CD7FECDF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986125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3.xml"/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グループ化 2"/>
          <p:cNvGrpSpPr/>
          <p:nvPr/>
        </p:nvGrpSpPr>
        <p:grpSpPr>
          <a:xfrm>
            <a:off x="207915" y="76200"/>
            <a:ext cx="6279969" cy="9131283"/>
            <a:chOff x="420219" y="337466"/>
            <a:chExt cx="5724798" cy="8738222"/>
          </a:xfrm>
        </p:grpSpPr>
        <p:sp>
          <p:nvSpPr>
            <p:cNvPr id="9" name="Text Box 347"/>
            <p:cNvSpPr txBox="1">
              <a:spLocks noChangeArrowheads="1"/>
            </p:cNvSpPr>
            <p:nvPr/>
          </p:nvSpPr>
          <p:spPr bwMode="auto">
            <a:xfrm>
              <a:off x="420219" y="7998470"/>
              <a:ext cx="5724798" cy="107721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 algn="just"/>
              <a:r>
                <a:rPr lang="en-US" altLang="ja-JP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gure S1. Analysis of identified proteins in GO molecular functions. Differentially expressed proteins were assigned to GO term categories related to molecular functions, and only significant categories (</a:t>
              </a:r>
              <a:r>
                <a:rPr lang="en-US" altLang="ja-JP" sz="16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</a:t>
              </a:r>
              <a:r>
                <a:rPr lang="en-US" altLang="ja-JP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&lt;0.05) were shown.</a:t>
              </a:r>
              <a:endParaRPr lang="ja-JP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2" name="図 1"/>
            <p:cNvPicPr>
              <a:picLocks noChangeAspect="1"/>
            </p:cNvPicPr>
            <p:nvPr/>
          </p:nvPicPr>
          <p:blipFill rotWithShape="1">
            <a:blip r:embed="rId2"/>
            <a:srcRect l="2220" t="6007" r="6031" b="13917"/>
            <a:stretch/>
          </p:blipFill>
          <p:spPr>
            <a:xfrm>
              <a:off x="730431" y="337466"/>
              <a:ext cx="4511561" cy="7661004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22554539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 Box 347"/>
          <p:cNvSpPr txBox="1">
            <a:spLocks noChangeArrowheads="1"/>
          </p:cNvSpPr>
          <p:nvPr/>
        </p:nvSpPr>
        <p:spPr bwMode="auto">
          <a:xfrm>
            <a:off x="1002421" y="6486525"/>
            <a:ext cx="5278636" cy="107721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algn="just" eaLnBrk="1" hangingPunct="1"/>
            <a:r>
              <a:rPr lang="en-US" altLang="ja-JP" sz="1600" dirty="0">
                <a:latin typeface="Times New Roman" pitchFamily="18" charset="0"/>
              </a:rPr>
              <a:t>Figure S2. Analysis of identified proteins in GO biological processes. Differentially expressed proteins were assigned to GO term categories related to biological processes, and only significant categories (p&lt;0.05) were shown.</a:t>
            </a:r>
            <a:endParaRPr lang="en-US" altLang="ja-JP" sz="1600" dirty="0">
              <a:latin typeface="Times New Roman" pitchFamily="18" charset="0"/>
            </a:endParaRPr>
          </a:p>
        </p:txBody>
      </p:sp>
      <p:graphicFrame>
        <p:nvGraphicFramePr>
          <p:cNvPr id="6" name="グラフ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49456662"/>
              </p:ext>
            </p:extLst>
          </p:nvPr>
        </p:nvGraphicFramePr>
        <p:xfrm>
          <a:off x="1122163" y="1905000"/>
          <a:ext cx="4549293" cy="466861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305157423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 Box 347"/>
          <p:cNvSpPr txBox="1">
            <a:spLocks noChangeArrowheads="1"/>
          </p:cNvSpPr>
          <p:nvPr/>
        </p:nvSpPr>
        <p:spPr bwMode="auto">
          <a:xfrm>
            <a:off x="838744" y="7266214"/>
            <a:ext cx="5180512" cy="107721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altLang="ja-JP" sz="1600" dirty="0">
                <a:latin typeface="Times New Roman" pitchFamily="18" charset="0"/>
              </a:rPr>
              <a:t>Figure S3. Analysis of identified proteins in GO pathways. Differentially expressed proteins were assigned to GO term categories related to pathways, and only significant categories (p&lt;0.05) were shown.</a:t>
            </a:r>
            <a:endParaRPr lang="en-US" altLang="ja-JP" sz="1600" dirty="0">
              <a:latin typeface="Times New Roman" pitchFamily="18" charset="0"/>
            </a:endParaRPr>
          </a:p>
        </p:txBody>
      </p:sp>
      <p:graphicFrame>
        <p:nvGraphicFramePr>
          <p:cNvPr id="5" name="グラフ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81263678"/>
              </p:ext>
            </p:extLst>
          </p:nvPr>
        </p:nvGraphicFramePr>
        <p:xfrm>
          <a:off x="1952625" y="2228850"/>
          <a:ext cx="2952750" cy="468629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6" name="グラフ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62763131"/>
              </p:ext>
            </p:extLst>
          </p:nvPr>
        </p:nvGraphicFramePr>
        <p:xfrm>
          <a:off x="700766" y="1186543"/>
          <a:ext cx="4926603" cy="607967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181415840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31</TotalTime>
  <Words>115</Words>
  <Application>Microsoft Office PowerPoint</Application>
  <PresentationFormat>画面に合わせる (4:3)</PresentationFormat>
  <Paragraphs>6</Paragraphs>
  <Slides>3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7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11" baseType="lpstr">
      <vt:lpstr>ＭＳ Ｐゴシック</vt:lpstr>
      <vt:lpstr>游ゴシック</vt:lpstr>
      <vt:lpstr>游ゴシック Light</vt:lpstr>
      <vt:lpstr>Arial</vt:lpstr>
      <vt:lpstr>Calibri</vt:lpstr>
      <vt:lpstr>Calibri Light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</dc:title>
  <dc:creator>otake</dc:creator>
  <cp:lastModifiedBy>yamatetsu</cp:lastModifiedBy>
  <cp:revision>21</cp:revision>
  <cp:lastPrinted>2018-06-22T04:32:58Z</cp:lastPrinted>
  <dcterms:created xsi:type="dcterms:W3CDTF">2018-04-26T11:06:28Z</dcterms:created>
  <dcterms:modified xsi:type="dcterms:W3CDTF">2018-06-22T04:33:13Z</dcterms:modified>
</cp:coreProperties>
</file>